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  <p:sldId id="266" r:id="rId3"/>
    <p:sldId id="265" r:id="rId4"/>
  </p:sldIdLst>
  <p:sldSz cx="6858000" cy="9906000" type="A4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63" autoAdjust="0"/>
    <p:restoredTop sz="94660"/>
  </p:normalViewPr>
  <p:slideViewPr>
    <p:cSldViewPr snapToGrid="0">
      <p:cViewPr varScale="1">
        <p:scale>
          <a:sx n="64" d="100"/>
          <a:sy n="64" d="100"/>
        </p:scale>
        <p:origin x="1506" y="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asumit\Desktop\Data\Data\Report\Os1348&#29992;\Growth%20in%20GCM%2020180713-0714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asumit\Desktop\Data\Data\Report\Os1348&#29992;\Growth%20in%20GCM%2020180713-0714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WT</c:v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GABAあり!$C$11:$H$11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9.0921211313238996E-3</c:v>
                  </c:pt>
                  <c:pt idx="2">
                    <c:v>8.2192186706253091E-3</c:v>
                  </c:pt>
                  <c:pt idx="3">
                    <c:v>1.1469767022723513E-2</c:v>
                  </c:pt>
                  <c:pt idx="4">
                    <c:v>2.4513035081133647E-2</c:v>
                  </c:pt>
                  <c:pt idx="5">
                    <c:v>4.0672130780452363E-2</c:v>
                  </c:pt>
                </c:numCache>
              </c:numRef>
            </c:plus>
            <c:minus>
              <c:numRef>
                <c:f>GABAあり!$C$11:$H$11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9.0921211313238996E-3</c:v>
                  </c:pt>
                  <c:pt idx="2">
                    <c:v>8.2192186706253091E-3</c:v>
                  </c:pt>
                  <c:pt idx="3">
                    <c:v>1.1469767022723513E-2</c:v>
                  </c:pt>
                  <c:pt idx="4">
                    <c:v>2.4513035081133647E-2</c:v>
                  </c:pt>
                  <c:pt idx="5">
                    <c:v>4.067213078045236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GABAあり!$C$5:$H$5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12</c:v>
                </c:pt>
                <c:pt idx="5">
                  <c:v>22</c:v>
                </c:pt>
              </c:numCache>
            </c:numRef>
          </c:xVal>
          <c:yVal>
            <c:numRef>
              <c:f>GABAあり!$C$10:$H$10</c:f>
              <c:numCache>
                <c:formatCode>General</c:formatCode>
                <c:ptCount val="6"/>
                <c:pt idx="0">
                  <c:v>0.04</c:v>
                </c:pt>
                <c:pt idx="1">
                  <c:v>0.13</c:v>
                </c:pt>
                <c:pt idx="2">
                  <c:v>0.19266666666666668</c:v>
                </c:pt>
                <c:pt idx="3">
                  <c:v>0.25466666666666665</c:v>
                </c:pt>
                <c:pt idx="4">
                  <c:v>0.39666666666666667</c:v>
                </c:pt>
                <c:pt idx="5">
                  <c:v>0.5266666666666666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E33-6642-A6BA-5B388EE8B850}"/>
            </c:ext>
          </c:extLst>
        </c:ser>
        <c:ser>
          <c:idx val="1"/>
          <c:order val="1"/>
          <c:tx>
            <c:v>1348</c:v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square"/>
            <c:size val="6"/>
            <c:spPr>
              <a:solidFill>
                <a:schemeClr val="bg1"/>
              </a:solidFill>
              <a:ln w="1905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GABAあり!$C$17:$H$17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9.8432153734889366E-3</c:v>
                  </c:pt>
                  <c:pt idx="2">
                    <c:v>9.9777530313971737E-3</c:v>
                  </c:pt>
                  <c:pt idx="3">
                    <c:v>1.7663521732655698E-2</c:v>
                  </c:pt>
                  <c:pt idx="4">
                    <c:v>2.6246692913372699E-2</c:v>
                  </c:pt>
                  <c:pt idx="5">
                    <c:v>3.4344658326376697E-2</c:v>
                  </c:pt>
                </c:numCache>
              </c:numRef>
            </c:plus>
            <c:minus>
              <c:numRef>
                <c:f>GABAあり!$C$17:$H$17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9.8432153734889366E-3</c:v>
                  </c:pt>
                  <c:pt idx="2">
                    <c:v>9.9777530313971737E-3</c:v>
                  </c:pt>
                  <c:pt idx="3">
                    <c:v>1.7663521732655698E-2</c:v>
                  </c:pt>
                  <c:pt idx="4">
                    <c:v>2.6246692913372699E-2</c:v>
                  </c:pt>
                  <c:pt idx="5">
                    <c:v>3.434465832637669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GABAあり!$C$5:$H$5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12</c:v>
                </c:pt>
                <c:pt idx="5">
                  <c:v>22</c:v>
                </c:pt>
              </c:numCache>
            </c:numRef>
          </c:xVal>
          <c:yVal>
            <c:numRef>
              <c:f>GABAあり!$C$16:$H$16</c:f>
              <c:numCache>
                <c:formatCode>General</c:formatCode>
                <c:ptCount val="6"/>
                <c:pt idx="0">
                  <c:v>0.04</c:v>
                </c:pt>
                <c:pt idx="1">
                  <c:v>0.12133333333333333</c:v>
                </c:pt>
                <c:pt idx="2">
                  <c:v>0.18333333333333335</c:v>
                </c:pt>
                <c:pt idx="3">
                  <c:v>0.248</c:v>
                </c:pt>
                <c:pt idx="4">
                  <c:v>0.4286666666666667</c:v>
                </c:pt>
                <c:pt idx="5">
                  <c:v>0.4613333333333333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E33-6642-A6BA-5B388EE8B850}"/>
            </c:ext>
          </c:extLst>
        </c:ser>
        <c:ser>
          <c:idx val="2"/>
          <c:order val="2"/>
          <c:tx>
            <c:v>1349</c:v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1905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GABAあり!$C$23:$H$23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9.0921211313238996E-3</c:v>
                  </c:pt>
                  <c:pt idx="2">
                    <c:v>9.4280904158206415E-4</c:v>
                  </c:pt>
                  <c:pt idx="3">
                    <c:v>2.8331372481167721E-2</c:v>
                  </c:pt>
                  <c:pt idx="4">
                    <c:v>2.7047283700134393E-2</c:v>
                  </c:pt>
                  <c:pt idx="5">
                    <c:v>1.9482185594936627E-2</c:v>
                  </c:pt>
                </c:numCache>
                <c:extLst xmlns:c15="http://schemas.microsoft.com/office/drawing/2012/chart"/>
              </c:numRef>
            </c:plus>
            <c:minus>
              <c:numRef>
                <c:f>GABAあり!$C$23:$H$23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9.0921211313238996E-3</c:v>
                  </c:pt>
                  <c:pt idx="2">
                    <c:v>9.4280904158206415E-4</c:v>
                  </c:pt>
                  <c:pt idx="3">
                    <c:v>2.8331372481167721E-2</c:v>
                  </c:pt>
                  <c:pt idx="4">
                    <c:v>2.7047283700134393E-2</c:v>
                  </c:pt>
                  <c:pt idx="5">
                    <c:v>1.9482185594936627E-2</c:v>
                  </c:pt>
                </c:numCache>
                <c:extLst xmlns:c15="http://schemas.microsoft.com/office/drawing/2012/chart"/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GABAあり!$C$5:$H$5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12</c:v>
                </c:pt>
                <c:pt idx="5">
                  <c:v>22</c:v>
                </c:pt>
              </c:numCache>
              <c:extLst xmlns:c15="http://schemas.microsoft.com/office/drawing/2012/chart"/>
            </c:numRef>
          </c:xVal>
          <c:yVal>
            <c:numRef>
              <c:f>GABAあり!$C$22:$H$22</c:f>
              <c:numCache>
                <c:formatCode>General</c:formatCode>
                <c:ptCount val="6"/>
                <c:pt idx="0">
                  <c:v>0.04</c:v>
                </c:pt>
                <c:pt idx="1">
                  <c:v>0.13800000000000001</c:v>
                </c:pt>
                <c:pt idx="2">
                  <c:v>0.19066666666666668</c:v>
                </c:pt>
                <c:pt idx="3">
                  <c:v>0.26599999999999996</c:v>
                </c:pt>
                <c:pt idx="4">
                  <c:v>0.3746666666666667</c:v>
                </c:pt>
                <c:pt idx="5">
                  <c:v>0.53266666666666673</c:v>
                </c:pt>
              </c:numCache>
              <c:extLst xmlns:c15="http://schemas.microsoft.com/office/drawing/2012/chart"/>
            </c:numRef>
          </c:yVal>
          <c:smooth val="0"/>
          <c:extLst>
            <c:ext xmlns:c16="http://schemas.microsoft.com/office/drawing/2014/chart" uri="{C3380CC4-5D6E-409C-BE32-E72D297353CC}">
              <c16:uniqueId val="{00000002-2E33-6642-A6BA-5B388EE8B850}"/>
            </c:ext>
          </c:extLst>
        </c:ser>
        <c:ser>
          <c:idx val="3"/>
          <c:order val="3"/>
          <c:tx>
            <c:v>1350</c:v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6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GABAあり!$C$29:$H$2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7.1180521680208808E-3</c:v>
                  </c:pt>
                  <c:pt idx="2">
                    <c:v>1.3097921802925667E-2</c:v>
                  </c:pt>
                  <c:pt idx="3">
                    <c:v>2.2861904265976316E-2</c:v>
                  </c:pt>
                  <c:pt idx="4">
                    <c:v>4.0276819911981919E-2</c:v>
                  </c:pt>
                  <c:pt idx="5">
                    <c:v>7.8841613377708245E-2</c:v>
                  </c:pt>
                </c:numCache>
              </c:numRef>
            </c:plus>
            <c:minus>
              <c:numRef>
                <c:f>GABAあり!$C$29:$H$2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7.1180521680208808E-3</c:v>
                  </c:pt>
                  <c:pt idx="2">
                    <c:v>1.3097921802925667E-2</c:v>
                  </c:pt>
                  <c:pt idx="3">
                    <c:v>2.2861904265976316E-2</c:v>
                  </c:pt>
                  <c:pt idx="4">
                    <c:v>4.0276819911981919E-2</c:v>
                  </c:pt>
                  <c:pt idx="5">
                    <c:v>7.8841613377708245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GABAあり!$C$5:$H$5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12</c:v>
                </c:pt>
                <c:pt idx="5">
                  <c:v>22</c:v>
                </c:pt>
              </c:numCache>
            </c:numRef>
          </c:xVal>
          <c:yVal>
            <c:numRef>
              <c:f>GABAあり!$C$28:$H$28</c:f>
              <c:numCache>
                <c:formatCode>General</c:formatCode>
                <c:ptCount val="6"/>
                <c:pt idx="0">
                  <c:v>0.04</c:v>
                </c:pt>
                <c:pt idx="1">
                  <c:v>0.124</c:v>
                </c:pt>
                <c:pt idx="2">
                  <c:v>0.18866666666666665</c:v>
                </c:pt>
                <c:pt idx="3">
                  <c:v>0.25800000000000001</c:v>
                </c:pt>
                <c:pt idx="4">
                  <c:v>0.40533333333333338</c:v>
                </c:pt>
                <c:pt idx="5">
                  <c:v>0.4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2E33-6642-A6BA-5B388EE8B850}"/>
            </c:ext>
          </c:extLst>
        </c:ser>
        <c:ser>
          <c:idx val="4"/>
          <c:order val="4"/>
          <c:tx>
            <c:v>1351</c:v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6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GABAあり!$C$35:$H$3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9.9777530313971807E-3</c:v>
                  </c:pt>
                  <c:pt idx="2">
                    <c:v>5.2493385826745459E-3</c:v>
                  </c:pt>
                  <c:pt idx="3">
                    <c:v>7.4833147735478894E-3</c:v>
                  </c:pt>
                  <c:pt idx="4">
                    <c:v>3.1496031496047232E-2</c:v>
                  </c:pt>
                  <c:pt idx="5">
                    <c:v>1.9798989873223323E-2</c:v>
                  </c:pt>
                </c:numCache>
              </c:numRef>
            </c:plus>
            <c:minus>
              <c:numRef>
                <c:f>GABAあり!$C$35:$H$3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9.9777530313971807E-3</c:v>
                  </c:pt>
                  <c:pt idx="2">
                    <c:v>5.2493385826745459E-3</c:v>
                  </c:pt>
                  <c:pt idx="3">
                    <c:v>7.4833147735478894E-3</c:v>
                  </c:pt>
                  <c:pt idx="4">
                    <c:v>3.1496031496047232E-2</c:v>
                  </c:pt>
                  <c:pt idx="5">
                    <c:v>1.979898987322332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GABAあり!$C$5:$H$5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12</c:v>
                </c:pt>
                <c:pt idx="5">
                  <c:v>22</c:v>
                </c:pt>
              </c:numCache>
            </c:numRef>
          </c:xVal>
          <c:yVal>
            <c:numRef>
              <c:f>GABAあり!$C$34:$H$34</c:f>
              <c:numCache>
                <c:formatCode>General</c:formatCode>
                <c:ptCount val="6"/>
                <c:pt idx="0">
                  <c:v>0.04</c:v>
                </c:pt>
                <c:pt idx="1">
                  <c:v>0.12466666666666666</c:v>
                </c:pt>
                <c:pt idx="2">
                  <c:v>0.18333333333333335</c:v>
                </c:pt>
                <c:pt idx="3">
                  <c:v>0.252</c:v>
                </c:pt>
                <c:pt idx="4">
                  <c:v>0.42799999999999994</c:v>
                </c:pt>
                <c:pt idx="5">
                  <c:v>0.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2E33-6642-A6BA-5B388EE8B850}"/>
            </c:ext>
          </c:extLst>
        </c:ser>
        <c:ser>
          <c:idx val="5"/>
          <c:order val="5"/>
          <c:tx>
            <c:v>1353</c:v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905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GABAあり!$C$41:$H$41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2.8284271247461861E-3</c:v>
                  </c:pt>
                  <c:pt idx="2">
                    <c:v>1.5173075568988057E-2</c:v>
                  </c:pt>
                  <c:pt idx="3">
                    <c:v>8.6409875978771464E-3</c:v>
                  </c:pt>
                  <c:pt idx="4">
                    <c:v>1.9252705437591552E-2</c:v>
                  </c:pt>
                  <c:pt idx="5">
                    <c:v>2.3151673805580447E-2</c:v>
                  </c:pt>
                </c:numCache>
                <c:extLst xmlns:c15="http://schemas.microsoft.com/office/drawing/2012/chart"/>
              </c:numRef>
            </c:plus>
            <c:minus>
              <c:numRef>
                <c:f>GABAあり!$C$41:$H$41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2.8284271247461861E-3</c:v>
                  </c:pt>
                  <c:pt idx="2">
                    <c:v>1.5173075568988057E-2</c:v>
                  </c:pt>
                  <c:pt idx="3">
                    <c:v>8.6409875978771464E-3</c:v>
                  </c:pt>
                  <c:pt idx="4">
                    <c:v>1.9252705437591552E-2</c:v>
                  </c:pt>
                  <c:pt idx="5">
                    <c:v>2.3151673805580447E-2</c:v>
                  </c:pt>
                </c:numCache>
                <c:extLst xmlns:c15="http://schemas.microsoft.com/office/drawing/2012/chart"/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GABAあり!$C$5:$H$5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12</c:v>
                </c:pt>
                <c:pt idx="5">
                  <c:v>22</c:v>
                </c:pt>
              </c:numCache>
              <c:extLst xmlns:c15="http://schemas.microsoft.com/office/drawing/2012/chart"/>
            </c:numRef>
          </c:xVal>
          <c:yVal>
            <c:numRef>
              <c:f>GABAあり!$C$40:$H$40</c:f>
              <c:numCache>
                <c:formatCode>General</c:formatCode>
                <c:ptCount val="6"/>
                <c:pt idx="0">
                  <c:v>0.04</c:v>
                </c:pt>
                <c:pt idx="1">
                  <c:v>0.11799999999999999</c:v>
                </c:pt>
                <c:pt idx="2">
                  <c:v>0.17666666666666667</c:v>
                </c:pt>
                <c:pt idx="3">
                  <c:v>0.24</c:v>
                </c:pt>
                <c:pt idx="4">
                  <c:v>0.38599999999999995</c:v>
                </c:pt>
                <c:pt idx="5">
                  <c:v>0.48199999999999998</c:v>
                </c:pt>
              </c:numCache>
              <c:extLst xmlns:c15="http://schemas.microsoft.com/office/drawing/2012/chart"/>
            </c:numRef>
          </c:yVal>
          <c:smooth val="0"/>
          <c:extLst>
            <c:ext xmlns:c16="http://schemas.microsoft.com/office/drawing/2014/chart" uri="{C3380CC4-5D6E-409C-BE32-E72D297353CC}">
              <c16:uniqueId val="{00000005-2E33-6642-A6BA-5B388EE8B8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69023488"/>
        <c:axId val="135671808"/>
        <c:extLst/>
      </c:scatterChart>
      <c:valAx>
        <c:axId val="269023488"/>
        <c:scaling>
          <c:orientation val="minMax"/>
          <c:max val="25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ja-JP"/>
          </a:p>
        </c:txPr>
        <c:crossAx val="135671808"/>
        <c:crossesAt val="1.0000000000000002E-2"/>
        <c:crossBetween val="midCat"/>
      </c:valAx>
      <c:valAx>
        <c:axId val="135671808"/>
        <c:scaling>
          <c:logBase val="10"/>
          <c:orientation val="minMax"/>
          <c:min val="1.0000000000000002E-2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ja-JP"/>
          </a:p>
        </c:txPr>
        <c:crossAx val="269023488"/>
        <c:crosses val="autoZero"/>
        <c:crossBetween val="midCat"/>
      </c:valAx>
      <c:spPr>
        <a:noFill/>
        <a:ln w="19050">
          <a:solidFill>
            <a:sysClr val="windowText" lastClr="000000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WT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bg1"/>
              </a:solidFill>
              <a:ln w="2857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GABAあり!$C$11:$H$11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9.0921211313238996E-3</c:v>
                  </c:pt>
                  <c:pt idx="2">
                    <c:v>8.2192186706253091E-3</c:v>
                  </c:pt>
                  <c:pt idx="3">
                    <c:v>1.1469767022723513E-2</c:v>
                  </c:pt>
                  <c:pt idx="4">
                    <c:v>2.4513035081133647E-2</c:v>
                  </c:pt>
                  <c:pt idx="5">
                    <c:v>4.0672130780452363E-2</c:v>
                  </c:pt>
                </c:numCache>
              </c:numRef>
            </c:plus>
            <c:minus>
              <c:numRef>
                <c:f>GABAあり!$C$11:$H$11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9.0921211313238996E-3</c:v>
                  </c:pt>
                  <c:pt idx="2">
                    <c:v>8.2192186706253091E-3</c:v>
                  </c:pt>
                  <c:pt idx="3">
                    <c:v>1.1469767022723513E-2</c:v>
                  </c:pt>
                  <c:pt idx="4">
                    <c:v>2.4513035081133647E-2</c:v>
                  </c:pt>
                  <c:pt idx="5">
                    <c:v>4.067213078045236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GABAあり!$C$5:$H$5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12</c:v>
                </c:pt>
                <c:pt idx="5">
                  <c:v>22</c:v>
                </c:pt>
              </c:numCache>
            </c:numRef>
          </c:xVal>
          <c:yVal>
            <c:numRef>
              <c:f>GABAあり!$C$10:$H$10</c:f>
              <c:numCache>
                <c:formatCode>General</c:formatCode>
                <c:ptCount val="6"/>
                <c:pt idx="0">
                  <c:v>0.04</c:v>
                </c:pt>
                <c:pt idx="1">
                  <c:v>0.13</c:v>
                </c:pt>
                <c:pt idx="2">
                  <c:v>0.19266666666666668</c:v>
                </c:pt>
                <c:pt idx="3">
                  <c:v>0.25466666666666665</c:v>
                </c:pt>
                <c:pt idx="4">
                  <c:v>0.39666666666666667</c:v>
                </c:pt>
                <c:pt idx="5">
                  <c:v>0.5266666666666666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05F-AB42-9626-CB6994901569}"/>
            </c:ext>
          </c:extLst>
        </c:ser>
        <c:ser>
          <c:idx val="1"/>
          <c:order val="1"/>
          <c:tx>
            <c:v>gacA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6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GABAあり!$C$47:$H$47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7.363574011458175E-3</c:v>
                  </c:pt>
                  <c:pt idx="2">
                    <c:v>4.8989794855663496E-3</c:v>
                  </c:pt>
                  <c:pt idx="3">
                    <c:v>4.1096093353126424E-3</c:v>
                  </c:pt>
                  <c:pt idx="4">
                    <c:v>9.9331096171675678E-3</c:v>
                  </c:pt>
                  <c:pt idx="5">
                    <c:v>1.8061622912192082E-2</c:v>
                  </c:pt>
                </c:numCache>
              </c:numRef>
            </c:plus>
            <c:minus>
              <c:numRef>
                <c:f>GABAあり!$C$47:$H$47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7.363574011458175E-3</c:v>
                  </c:pt>
                  <c:pt idx="2">
                    <c:v>4.8989794855663496E-3</c:v>
                  </c:pt>
                  <c:pt idx="3">
                    <c:v>4.1096093353126424E-3</c:v>
                  </c:pt>
                  <c:pt idx="4">
                    <c:v>9.9331096171675678E-3</c:v>
                  </c:pt>
                  <c:pt idx="5">
                    <c:v>1.806162291219208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GABAあり!$C$5:$H$5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12</c:v>
                </c:pt>
                <c:pt idx="5">
                  <c:v>22</c:v>
                </c:pt>
              </c:numCache>
            </c:numRef>
          </c:xVal>
          <c:yVal>
            <c:numRef>
              <c:f>GABAあり!$C$46:$H$46</c:f>
              <c:numCache>
                <c:formatCode>General</c:formatCode>
                <c:ptCount val="6"/>
                <c:pt idx="0">
                  <c:v>0.04</c:v>
                </c:pt>
                <c:pt idx="1">
                  <c:v>0.12133333333333333</c:v>
                </c:pt>
                <c:pt idx="2">
                  <c:v>0.16600000000000001</c:v>
                </c:pt>
                <c:pt idx="3">
                  <c:v>0.23733333333333331</c:v>
                </c:pt>
                <c:pt idx="4">
                  <c:v>0.27</c:v>
                </c:pt>
                <c:pt idx="5">
                  <c:v>0.301333333333333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05F-AB42-9626-CB6994901569}"/>
            </c:ext>
          </c:extLst>
        </c:ser>
        <c:ser>
          <c:idx val="2"/>
          <c:order val="2"/>
          <c:tx>
            <c:v>phlD</c:v>
          </c:tx>
          <c:spPr>
            <a:ln w="28575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1905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GABAあり!$C$53:$H$53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7.3635740114581742E-3</c:v>
                  </c:pt>
                  <c:pt idx="2">
                    <c:v>1.3695092389449423E-2</c:v>
                  </c:pt>
                  <c:pt idx="3">
                    <c:v>1.4966629547095767E-2</c:v>
                  </c:pt>
                  <c:pt idx="4">
                    <c:v>7.4833147735478894E-3</c:v>
                  </c:pt>
                  <c:pt idx="5">
                    <c:v>4.9915484126226109E-2</c:v>
                  </c:pt>
                </c:numCache>
              </c:numRef>
            </c:plus>
            <c:minus>
              <c:numRef>
                <c:f>GABAあり!$C$53:$H$53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7.3635740114581742E-3</c:v>
                  </c:pt>
                  <c:pt idx="2">
                    <c:v>1.3695092389449423E-2</c:v>
                  </c:pt>
                  <c:pt idx="3">
                    <c:v>1.4966629547095767E-2</c:v>
                  </c:pt>
                  <c:pt idx="4">
                    <c:v>7.4833147735478894E-3</c:v>
                  </c:pt>
                  <c:pt idx="5">
                    <c:v>4.9915484126226109E-2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GABAあり!$C$5:$H$5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12</c:v>
                </c:pt>
                <c:pt idx="5">
                  <c:v>22</c:v>
                </c:pt>
              </c:numCache>
              <c:extLst xmlns:c15="http://schemas.microsoft.com/office/drawing/2012/chart"/>
            </c:numRef>
          </c:xVal>
          <c:yVal>
            <c:numRef>
              <c:f>GABAあり!$C$52:$H$52</c:f>
              <c:numCache>
                <c:formatCode>General</c:formatCode>
                <c:ptCount val="6"/>
                <c:pt idx="0">
                  <c:v>0.04</c:v>
                </c:pt>
                <c:pt idx="1">
                  <c:v>0.12133333333333333</c:v>
                </c:pt>
                <c:pt idx="2">
                  <c:v>0.16733333333333333</c:v>
                </c:pt>
                <c:pt idx="3">
                  <c:v>0.24399999999999999</c:v>
                </c:pt>
                <c:pt idx="4">
                  <c:v>0.38199999999999995</c:v>
                </c:pt>
                <c:pt idx="5">
                  <c:v>0.437333333333333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205F-AB42-9626-CB6994901569}"/>
            </c:ext>
          </c:extLst>
        </c:ser>
        <c:ser>
          <c:idx val="3"/>
          <c:order val="3"/>
          <c:tx>
            <c:v>phlD1348</c:v>
          </c:tx>
          <c:spPr>
            <a:ln w="28575" cap="rnd">
              <a:solidFill>
                <a:sysClr val="windowText" lastClr="000000"/>
              </a:solidFill>
              <a:round/>
            </a:ln>
            <a:effectLst/>
          </c:spPr>
          <c:marker>
            <c:symbol val="triangle"/>
            <c:size val="6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GABAあり!$C$59:$H$5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7.4833147735478842E-3</c:v>
                  </c:pt>
                  <c:pt idx="2">
                    <c:v>1.9754043186705369E-2</c:v>
                  </c:pt>
                  <c:pt idx="3">
                    <c:v>9.5684667296048916E-3</c:v>
                  </c:pt>
                  <c:pt idx="4">
                    <c:v>3.2714251057027459E-2</c:v>
                  </c:pt>
                  <c:pt idx="5">
                    <c:v>2.7760883751542686E-2</c:v>
                  </c:pt>
                </c:numCache>
              </c:numRef>
            </c:plus>
            <c:minus>
              <c:numRef>
                <c:f>GABAあり!$C$59:$H$5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7.4833147735478842E-3</c:v>
                  </c:pt>
                  <c:pt idx="2">
                    <c:v>1.9754043186705369E-2</c:v>
                  </c:pt>
                  <c:pt idx="3">
                    <c:v>9.5684667296048916E-3</c:v>
                  </c:pt>
                  <c:pt idx="4">
                    <c:v>3.2714251057027459E-2</c:v>
                  </c:pt>
                  <c:pt idx="5">
                    <c:v>2.7760883751542686E-2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GABAあり!$C$5:$H$5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12</c:v>
                </c:pt>
                <c:pt idx="5">
                  <c:v>22</c:v>
                </c:pt>
              </c:numCache>
            </c:numRef>
          </c:xVal>
          <c:yVal>
            <c:numRef>
              <c:f>GABAあり!$C$58:$H$58</c:f>
              <c:numCache>
                <c:formatCode>General</c:formatCode>
                <c:ptCount val="6"/>
                <c:pt idx="0">
                  <c:v>0.04</c:v>
                </c:pt>
                <c:pt idx="1">
                  <c:v>0.122</c:v>
                </c:pt>
                <c:pt idx="2">
                  <c:v>0.16133333333333336</c:v>
                </c:pt>
                <c:pt idx="3">
                  <c:v>0.24933333333333332</c:v>
                </c:pt>
                <c:pt idx="4">
                  <c:v>0.40066666666666667</c:v>
                </c:pt>
                <c:pt idx="5">
                  <c:v>0.463999999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205F-AB42-9626-CB6994901569}"/>
            </c:ext>
          </c:extLst>
        </c:ser>
        <c:ser>
          <c:idx val="4"/>
          <c:order val="4"/>
          <c:tx>
            <c:v>phlD1353</c:v>
          </c:tx>
          <c:spPr>
            <a:ln w="28575" cap="rnd">
              <a:solidFill>
                <a:sysClr val="windowText" lastClr="000000"/>
              </a:solidFill>
              <a:round/>
            </a:ln>
            <a:effectLst/>
          </c:spPr>
          <c:marker>
            <c:symbol val="triangle"/>
            <c:size val="6"/>
            <c:spPr>
              <a:solidFill>
                <a:schemeClr val="bg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GABAあり!$C$65:$H$6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8.9938250421546951E-3</c:v>
                  </c:pt>
                  <c:pt idx="2">
                    <c:v>2.1312489817527511E-2</c:v>
                  </c:pt>
                  <c:pt idx="3">
                    <c:v>1.1430952132988174E-2</c:v>
                  </c:pt>
                  <c:pt idx="4">
                    <c:v>1.7204650534085247E-2</c:v>
                  </c:pt>
                  <c:pt idx="5">
                    <c:v>2.9454296045832672E-2</c:v>
                  </c:pt>
                </c:numCache>
              </c:numRef>
            </c:plus>
            <c:minus>
              <c:numRef>
                <c:f>GABAあり!$C$65:$H$6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8.9938250421546951E-3</c:v>
                  </c:pt>
                  <c:pt idx="2">
                    <c:v>2.1312489817527511E-2</c:v>
                  </c:pt>
                  <c:pt idx="3">
                    <c:v>1.1430952132988174E-2</c:v>
                  </c:pt>
                  <c:pt idx="4">
                    <c:v>1.7204650534085247E-2</c:v>
                  </c:pt>
                  <c:pt idx="5">
                    <c:v>2.9454296045832672E-2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GABAあり!$C$5:$H$5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12</c:v>
                </c:pt>
                <c:pt idx="5">
                  <c:v>22</c:v>
                </c:pt>
              </c:numCache>
            </c:numRef>
          </c:xVal>
          <c:yVal>
            <c:numRef>
              <c:f>GABAあり!$C$64:$H$64</c:f>
              <c:numCache>
                <c:formatCode>General</c:formatCode>
                <c:ptCount val="6"/>
                <c:pt idx="0">
                  <c:v>0.04</c:v>
                </c:pt>
                <c:pt idx="1">
                  <c:v>0.13466666666666668</c:v>
                </c:pt>
                <c:pt idx="2">
                  <c:v>0.18066666666666667</c:v>
                </c:pt>
                <c:pt idx="3">
                  <c:v>0.26</c:v>
                </c:pt>
                <c:pt idx="4">
                  <c:v>0.42399999999999999</c:v>
                </c:pt>
                <c:pt idx="5">
                  <c:v>0.563333333333333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205F-AB42-9626-CB69949015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5715072"/>
        <c:axId val="167231488"/>
        <c:extLst/>
      </c:scatterChart>
      <c:valAx>
        <c:axId val="135715072"/>
        <c:scaling>
          <c:orientation val="minMax"/>
          <c:max val="25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ja-JP"/>
          </a:p>
        </c:txPr>
        <c:crossAx val="167231488"/>
        <c:crossesAt val="1.0000000000000002E-2"/>
        <c:crossBetween val="midCat"/>
      </c:valAx>
      <c:valAx>
        <c:axId val="167231488"/>
        <c:scaling>
          <c:logBase val="10"/>
          <c:orientation val="minMax"/>
          <c:min val="1.0000000000000002E-2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ja-JP"/>
          </a:p>
        </c:txPr>
        <c:crossAx val="135715072"/>
        <c:crosses val="autoZero"/>
        <c:crossBetween val="midCat"/>
      </c:valAx>
      <c:spPr>
        <a:noFill/>
        <a:ln w="19050">
          <a:solidFill>
            <a:sysClr val="windowText" lastClr="000000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7D167-4707-47E9-BC0B-F1167D7937F2}" type="datetimeFigureOut">
              <a:rPr kumimoji="1" lang="ja-JP" altLang="en-US" smtClean="0"/>
              <a:t>2020/1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1F200-50F4-4035-ACEE-772B50D497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28499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7D167-4707-47E9-BC0B-F1167D7937F2}" type="datetimeFigureOut">
              <a:rPr kumimoji="1" lang="ja-JP" altLang="en-US" smtClean="0"/>
              <a:t>2020/1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1F200-50F4-4035-ACEE-772B50D497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52966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7D167-4707-47E9-BC0B-F1167D7937F2}" type="datetimeFigureOut">
              <a:rPr kumimoji="1" lang="ja-JP" altLang="en-US" smtClean="0"/>
              <a:t>2020/1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1F200-50F4-4035-ACEE-772B50D497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751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7D167-4707-47E9-BC0B-F1167D7937F2}" type="datetimeFigureOut">
              <a:rPr kumimoji="1" lang="ja-JP" altLang="en-US" smtClean="0"/>
              <a:t>2020/1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1F200-50F4-4035-ACEE-772B50D497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8656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7D167-4707-47E9-BC0B-F1167D7937F2}" type="datetimeFigureOut">
              <a:rPr kumimoji="1" lang="ja-JP" altLang="en-US" smtClean="0"/>
              <a:t>2020/1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1F200-50F4-4035-ACEE-772B50D497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49100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7D167-4707-47E9-BC0B-F1167D7937F2}" type="datetimeFigureOut">
              <a:rPr kumimoji="1" lang="ja-JP" altLang="en-US" smtClean="0"/>
              <a:t>2020/11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1F200-50F4-4035-ACEE-772B50D497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04632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7D167-4707-47E9-BC0B-F1167D7937F2}" type="datetimeFigureOut">
              <a:rPr kumimoji="1" lang="ja-JP" altLang="en-US" smtClean="0"/>
              <a:t>2020/11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1F200-50F4-4035-ACEE-772B50D497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1688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7D167-4707-47E9-BC0B-F1167D7937F2}" type="datetimeFigureOut">
              <a:rPr kumimoji="1" lang="ja-JP" altLang="en-US" smtClean="0"/>
              <a:t>2020/11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1F200-50F4-4035-ACEE-772B50D497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86086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7D167-4707-47E9-BC0B-F1167D7937F2}" type="datetimeFigureOut">
              <a:rPr kumimoji="1" lang="ja-JP" altLang="en-US" smtClean="0"/>
              <a:t>2020/11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1F200-50F4-4035-ACEE-772B50D497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44692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7D167-4707-47E9-BC0B-F1167D7937F2}" type="datetimeFigureOut">
              <a:rPr kumimoji="1" lang="ja-JP" altLang="en-US" smtClean="0"/>
              <a:t>2020/11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1F200-50F4-4035-ACEE-772B50D497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43705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7D167-4707-47E9-BC0B-F1167D7937F2}" type="datetimeFigureOut">
              <a:rPr kumimoji="1" lang="ja-JP" altLang="en-US" smtClean="0"/>
              <a:t>2020/11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1F200-50F4-4035-ACEE-772B50D497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55736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57D167-4707-47E9-BC0B-F1167D7937F2}" type="datetimeFigureOut">
              <a:rPr kumimoji="1" lang="ja-JP" altLang="en-US" smtClean="0"/>
              <a:t>2020/1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81F200-50F4-4035-ACEE-772B50D497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0848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eg"/><Relationship Id="rId5" Type="http://schemas.microsoft.com/office/2007/relationships/hdphoto" Target="../media/hdphoto2.wdp"/><Relationship Id="rId4" Type="http://schemas.openxmlformats.org/officeDocument/2006/relationships/image" Target="../media/image2.jpeg"/><Relationship Id="rId9" Type="http://schemas.microsoft.com/office/2007/relationships/hdphoto" Target="../media/hdphoto4.wdp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グラフ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81950420"/>
              </p:ext>
            </p:extLst>
          </p:nvPr>
        </p:nvGraphicFramePr>
        <p:xfrm>
          <a:off x="1432109" y="1787700"/>
          <a:ext cx="3807865" cy="26466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3632001"/>
              </p:ext>
            </p:extLst>
          </p:nvPr>
        </p:nvGraphicFramePr>
        <p:xfrm>
          <a:off x="1432109" y="4493190"/>
          <a:ext cx="3807865" cy="26473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正方形/長方形 79"/>
          <p:cNvSpPr>
            <a:spLocks noChangeArrowheads="1"/>
          </p:cNvSpPr>
          <p:nvPr/>
        </p:nvSpPr>
        <p:spPr bwMode="auto">
          <a:xfrm rot="16200000">
            <a:off x="552714" y="4085299"/>
            <a:ext cx="1451011" cy="30777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1" rIns="91440" bIns="45721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1400" b="1" dirty="0">
                <a:solidFill>
                  <a:prstClr val="black"/>
                </a:solidFill>
                <a:cs typeface="ＭＳ Ｐゴシック" pitchFamily="50" charset="-128"/>
              </a:rPr>
              <a:t>Growth (OD</a:t>
            </a:r>
            <a:r>
              <a:rPr lang="en-US" altLang="ja-JP" sz="1400" b="1" baseline="-25000" dirty="0">
                <a:solidFill>
                  <a:prstClr val="black"/>
                </a:solidFill>
                <a:cs typeface="ＭＳ Ｐゴシック" pitchFamily="50" charset="-128"/>
              </a:rPr>
              <a:t>600</a:t>
            </a:r>
            <a:r>
              <a:rPr lang="en-US" altLang="ja-JP" sz="1400" b="1" dirty="0">
                <a:solidFill>
                  <a:prstClr val="black"/>
                </a:solidFill>
                <a:cs typeface="ＭＳ Ｐゴシック" pitchFamily="50" charset="-128"/>
              </a:rPr>
              <a:t>)</a:t>
            </a:r>
            <a:endParaRPr lang="ja-JP" altLang="en-US" sz="1400" b="1" baseline="-25000" dirty="0">
              <a:solidFill>
                <a:prstClr val="black"/>
              </a:solidFill>
              <a:latin typeface="Arial" pitchFamily="34" charset="0"/>
              <a:cs typeface="ＭＳ Ｐゴシック" pitchFamily="50" charset="-128"/>
            </a:endParaRPr>
          </a:p>
        </p:txBody>
      </p:sp>
      <p:sp>
        <p:nvSpPr>
          <p:cNvPr id="6" name="正方形/長方形 79"/>
          <p:cNvSpPr>
            <a:spLocks noChangeArrowheads="1"/>
          </p:cNvSpPr>
          <p:nvPr/>
        </p:nvSpPr>
        <p:spPr bwMode="auto">
          <a:xfrm>
            <a:off x="2603646" y="7190458"/>
            <a:ext cx="2231151" cy="30777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1" rIns="91440" bIns="45721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1400" b="1" dirty="0">
                <a:solidFill>
                  <a:prstClr val="black"/>
                </a:solidFill>
                <a:cs typeface="ＭＳ Ｐゴシック" pitchFamily="50" charset="-128"/>
              </a:rPr>
              <a:t>Time after inoculation (h)</a:t>
            </a:r>
            <a:endParaRPr lang="ja-JP" altLang="en-US" sz="1400" b="1" baseline="-25000" dirty="0">
              <a:solidFill>
                <a:prstClr val="black"/>
              </a:solidFill>
              <a:latin typeface="Arial" pitchFamily="34" charset="0"/>
              <a:cs typeface="ＭＳ Ｐゴシック" pitchFamily="50" charset="-128"/>
            </a:endParaRPr>
          </a:p>
        </p:txBody>
      </p:sp>
      <p:grpSp>
        <p:nvGrpSpPr>
          <p:cNvPr id="2" name="グループ化 1"/>
          <p:cNvGrpSpPr/>
          <p:nvPr/>
        </p:nvGrpSpPr>
        <p:grpSpPr>
          <a:xfrm>
            <a:off x="3495962" y="2922485"/>
            <a:ext cx="1448248" cy="1092607"/>
            <a:chOff x="5897734" y="1164712"/>
            <a:chExt cx="1448248" cy="1092607"/>
          </a:xfrm>
        </p:grpSpPr>
        <p:sp>
          <p:nvSpPr>
            <p:cNvPr id="7" name="テキスト ボックス 6"/>
            <p:cNvSpPr txBox="1"/>
            <p:nvPr/>
          </p:nvSpPr>
          <p:spPr>
            <a:xfrm>
              <a:off x="6225162" y="1164712"/>
              <a:ext cx="1120820" cy="10926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1300"/>
                </a:lnSpc>
              </a:pPr>
              <a:r>
                <a:rPr lang="en-US" altLang="ja-JP" sz="1100" dirty="0">
                  <a:solidFill>
                    <a:prstClr val="black"/>
                  </a:solidFill>
                </a:rPr>
                <a:t>Os17 (wild type)</a:t>
              </a:r>
            </a:p>
            <a:p>
              <a:pPr>
                <a:lnSpc>
                  <a:spcPts val="1300"/>
                </a:lnSpc>
              </a:pPr>
              <a:r>
                <a:rPr lang="en-US" altLang="ja-JP" sz="1100" i="1" dirty="0">
                  <a:solidFill>
                    <a:prstClr val="black"/>
                  </a:solidFill>
                </a:rPr>
                <a:t>1348</a:t>
              </a:r>
            </a:p>
            <a:p>
              <a:pPr>
                <a:lnSpc>
                  <a:spcPts val="1300"/>
                </a:lnSpc>
              </a:pPr>
              <a:r>
                <a:rPr lang="en-US" altLang="ja-JP" sz="1100" i="1" dirty="0">
                  <a:solidFill>
                    <a:prstClr val="black"/>
                  </a:solidFill>
                </a:rPr>
                <a:t>1349</a:t>
              </a:r>
            </a:p>
            <a:p>
              <a:pPr>
                <a:lnSpc>
                  <a:spcPts val="1300"/>
                </a:lnSpc>
              </a:pPr>
              <a:r>
                <a:rPr lang="en-US" altLang="ja-JP" sz="1100" i="1" dirty="0">
                  <a:solidFill>
                    <a:prstClr val="black"/>
                  </a:solidFill>
                </a:rPr>
                <a:t>1350</a:t>
              </a:r>
            </a:p>
            <a:p>
              <a:pPr>
                <a:lnSpc>
                  <a:spcPts val="1300"/>
                </a:lnSpc>
              </a:pPr>
              <a:r>
                <a:rPr lang="en-US" altLang="ja-JP" sz="1100" i="1" dirty="0">
                  <a:solidFill>
                    <a:prstClr val="black"/>
                  </a:solidFill>
                </a:rPr>
                <a:t>1351</a:t>
              </a:r>
            </a:p>
            <a:p>
              <a:pPr>
                <a:lnSpc>
                  <a:spcPts val="1300"/>
                </a:lnSpc>
              </a:pPr>
              <a:r>
                <a:rPr lang="en-US" altLang="ja-JP" sz="1100" i="1" dirty="0">
                  <a:solidFill>
                    <a:prstClr val="black"/>
                  </a:solidFill>
                </a:rPr>
                <a:t>1353</a:t>
              </a:r>
            </a:p>
          </p:txBody>
        </p:sp>
        <p:cxnSp>
          <p:nvCxnSpPr>
            <p:cNvPr id="8" name="直線コネクタ 7"/>
            <p:cNvCxnSpPr/>
            <p:nvPr/>
          </p:nvCxnSpPr>
          <p:spPr>
            <a:xfrm>
              <a:off x="5909718" y="1293557"/>
              <a:ext cx="35992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円/楕円 8"/>
            <p:cNvSpPr/>
            <p:nvPr/>
          </p:nvSpPr>
          <p:spPr>
            <a:xfrm>
              <a:off x="6039914" y="1244046"/>
              <a:ext cx="96998" cy="98381"/>
            </a:xfrm>
            <a:prstGeom prst="ellipse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solidFill>
                  <a:prstClr val="white"/>
                </a:solidFill>
              </a:endParaRPr>
            </a:p>
          </p:txBody>
        </p:sp>
        <p:cxnSp>
          <p:nvCxnSpPr>
            <p:cNvPr id="10" name="直線コネクタ 9"/>
            <p:cNvCxnSpPr/>
            <p:nvPr/>
          </p:nvCxnSpPr>
          <p:spPr>
            <a:xfrm>
              <a:off x="5903094" y="1465835"/>
              <a:ext cx="35992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正方形/長方形 10"/>
            <p:cNvSpPr/>
            <p:nvPr/>
          </p:nvSpPr>
          <p:spPr>
            <a:xfrm>
              <a:off x="6043365" y="1423143"/>
              <a:ext cx="88809" cy="85384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solidFill>
                  <a:prstClr val="white"/>
                </a:solidFill>
              </a:endParaRPr>
            </a:p>
          </p:txBody>
        </p:sp>
        <p:cxnSp>
          <p:nvCxnSpPr>
            <p:cNvPr id="12" name="直線コネクタ 11"/>
            <p:cNvCxnSpPr/>
            <p:nvPr/>
          </p:nvCxnSpPr>
          <p:spPr>
            <a:xfrm>
              <a:off x="5909717" y="1622973"/>
              <a:ext cx="35992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線コネクタ 12"/>
            <p:cNvCxnSpPr/>
            <p:nvPr/>
          </p:nvCxnSpPr>
          <p:spPr>
            <a:xfrm>
              <a:off x="5903093" y="1779321"/>
              <a:ext cx="35992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二等辺三角形 13"/>
            <p:cNvSpPr/>
            <p:nvPr/>
          </p:nvSpPr>
          <p:spPr>
            <a:xfrm>
              <a:off x="6038045" y="1727592"/>
              <a:ext cx="90018" cy="94098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solidFill>
                  <a:prstClr val="white"/>
                </a:solidFill>
              </a:endParaRPr>
            </a:p>
          </p:txBody>
        </p:sp>
        <p:cxnSp>
          <p:nvCxnSpPr>
            <p:cNvPr id="16" name="直線コネクタ 15"/>
            <p:cNvCxnSpPr/>
            <p:nvPr/>
          </p:nvCxnSpPr>
          <p:spPr>
            <a:xfrm>
              <a:off x="5908007" y="1939757"/>
              <a:ext cx="35992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二等辺三角形 16"/>
            <p:cNvSpPr/>
            <p:nvPr/>
          </p:nvSpPr>
          <p:spPr>
            <a:xfrm>
              <a:off x="6036335" y="1887180"/>
              <a:ext cx="90018" cy="94098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solidFill>
                  <a:prstClr val="white"/>
                </a:solidFill>
              </a:endParaRPr>
            </a:p>
          </p:txBody>
        </p:sp>
        <p:cxnSp>
          <p:nvCxnSpPr>
            <p:cNvPr id="18" name="直線コネクタ 17"/>
            <p:cNvCxnSpPr/>
            <p:nvPr/>
          </p:nvCxnSpPr>
          <p:spPr>
            <a:xfrm>
              <a:off x="5897734" y="2113774"/>
              <a:ext cx="35992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円/楕円 18"/>
            <p:cNvSpPr/>
            <p:nvPr/>
          </p:nvSpPr>
          <p:spPr>
            <a:xfrm>
              <a:off x="6027930" y="2064263"/>
              <a:ext cx="96998" cy="98381"/>
            </a:xfrm>
            <a:prstGeom prst="ellipse">
              <a:avLst/>
            </a:prstGeom>
            <a:solidFill>
              <a:schemeClr val="tx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solidFill>
                  <a:prstClr val="white"/>
                </a:solidFill>
              </a:endParaRPr>
            </a:p>
          </p:txBody>
        </p:sp>
        <p:sp>
          <p:nvSpPr>
            <p:cNvPr id="22" name="円/楕円 21"/>
            <p:cNvSpPr/>
            <p:nvPr/>
          </p:nvSpPr>
          <p:spPr>
            <a:xfrm>
              <a:off x="6038204" y="1581378"/>
              <a:ext cx="96998" cy="98381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solidFill>
                  <a:prstClr val="white"/>
                </a:solidFill>
              </a:endParaRPr>
            </a:p>
          </p:txBody>
        </p:sp>
      </p:grpSp>
      <p:grpSp>
        <p:nvGrpSpPr>
          <p:cNvPr id="24" name="グループ化 23"/>
          <p:cNvGrpSpPr/>
          <p:nvPr/>
        </p:nvGrpSpPr>
        <p:grpSpPr>
          <a:xfrm>
            <a:off x="3495962" y="5719092"/>
            <a:ext cx="1442889" cy="925894"/>
            <a:chOff x="5903093" y="1164712"/>
            <a:chExt cx="1442889" cy="925894"/>
          </a:xfrm>
        </p:grpSpPr>
        <p:sp>
          <p:nvSpPr>
            <p:cNvPr id="25" name="テキスト ボックス 24"/>
            <p:cNvSpPr txBox="1"/>
            <p:nvPr/>
          </p:nvSpPr>
          <p:spPr>
            <a:xfrm>
              <a:off x="6225162" y="1164712"/>
              <a:ext cx="1120820" cy="9258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1300"/>
                </a:lnSpc>
              </a:pPr>
              <a:r>
                <a:rPr lang="en-US" altLang="ja-JP" sz="1100" dirty="0">
                  <a:solidFill>
                    <a:prstClr val="black"/>
                  </a:solidFill>
                </a:rPr>
                <a:t>Os17 (wild type)</a:t>
              </a:r>
            </a:p>
            <a:p>
              <a:pPr>
                <a:lnSpc>
                  <a:spcPts val="1300"/>
                </a:lnSpc>
              </a:pPr>
              <a:r>
                <a:rPr lang="en-US" altLang="ja-JP" sz="1100" i="1" dirty="0" err="1">
                  <a:solidFill>
                    <a:prstClr val="black"/>
                  </a:solidFill>
                </a:rPr>
                <a:t>gacA</a:t>
              </a:r>
              <a:endParaRPr lang="en-US" altLang="ja-JP" sz="1100" i="1" dirty="0">
                <a:solidFill>
                  <a:prstClr val="black"/>
                </a:solidFill>
              </a:endParaRPr>
            </a:p>
            <a:p>
              <a:pPr>
                <a:lnSpc>
                  <a:spcPts val="1300"/>
                </a:lnSpc>
              </a:pPr>
              <a:r>
                <a:rPr lang="en-US" altLang="ja-JP" sz="1100" i="1" dirty="0" err="1">
                  <a:solidFill>
                    <a:prstClr val="black"/>
                  </a:solidFill>
                </a:rPr>
                <a:t>phlD</a:t>
              </a:r>
              <a:endParaRPr lang="en-US" altLang="ja-JP" sz="1100" i="1" dirty="0">
                <a:solidFill>
                  <a:prstClr val="black"/>
                </a:solidFill>
              </a:endParaRPr>
            </a:p>
            <a:p>
              <a:pPr>
                <a:lnSpc>
                  <a:spcPts val="1300"/>
                </a:lnSpc>
              </a:pPr>
              <a:r>
                <a:rPr lang="en-US" altLang="ja-JP" sz="1100" i="1" dirty="0">
                  <a:solidFill>
                    <a:prstClr val="black"/>
                  </a:solidFill>
                </a:rPr>
                <a:t>1348/</a:t>
              </a:r>
              <a:r>
                <a:rPr lang="en-US" altLang="ja-JP" sz="1100" i="1" dirty="0" err="1">
                  <a:solidFill>
                    <a:prstClr val="black"/>
                  </a:solidFill>
                </a:rPr>
                <a:t>phlD</a:t>
              </a:r>
              <a:endParaRPr lang="en-US" altLang="ja-JP" sz="1100" i="1" dirty="0">
                <a:solidFill>
                  <a:prstClr val="black"/>
                </a:solidFill>
              </a:endParaRPr>
            </a:p>
            <a:p>
              <a:pPr>
                <a:lnSpc>
                  <a:spcPts val="1300"/>
                </a:lnSpc>
              </a:pPr>
              <a:r>
                <a:rPr lang="en-US" altLang="ja-JP" sz="1100" i="1" dirty="0">
                  <a:solidFill>
                    <a:prstClr val="black"/>
                  </a:solidFill>
                </a:rPr>
                <a:t>1353/</a:t>
              </a:r>
              <a:r>
                <a:rPr lang="en-US" altLang="ja-JP" sz="1100" i="1" dirty="0" err="1">
                  <a:solidFill>
                    <a:prstClr val="black"/>
                  </a:solidFill>
                </a:rPr>
                <a:t>phlD</a:t>
              </a:r>
              <a:endParaRPr lang="en-US" altLang="ja-JP" sz="1100" i="1" dirty="0">
                <a:solidFill>
                  <a:prstClr val="black"/>
                </a:solidFill>
              </a:endParaRPr>
            </a:p>
          </p:txBody>
        </p:sp>
        <p:cxnSp>
          <p:nvCxnSpPr>
            <p:cNvPr id="26" name="直線コネクタ 25"/>
            <p:cNvCxnSpPr/>
            <p:nvPr/>
          </p:nvCxnSpPr>
          <p:spPr>
            <a:xfrm>
              <a:off x="5909718" y="1293557"/>
              <a:ext cx="35992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円/楕円 26"/>
            <p:cNvSpPr/>
            <p:nvPr/>
          </p:nvSpPr>
          <p:spPr>
            <a:xfrm>
              <a:off x="6039914" y="1244046"/>
              <a:ext cx="96998" cy="98381"/>
            </a:xfrm>
            <a:prstGeom prst="ellipse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solidFill>
                  <a:prstClr val="white"/>
                </a:solidFill>
              </a:endParaRPr>
            </a:p>
          </p:txBody>
        </p:sp>
        <p:cxnSp>
          <p:nvCxnSpPr>
            <p:cNvPr id="28" name="直線コネクタ 27"/>
            <p:cNvCxnSpPr/>
            <p:nvPr/>
          </p:nvCxnSpPr>
          <p:spPr>
            <a:xfrm>
              <a:off x="5903094" y="1465835"/>
              <a:ext cx="35992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正方形/長方形 28"/>
            <p:cNvSpPr/>
            <p:nvPr/>
          </p:nvSpPr>
          <p:spPr>
            <a:xfrm>
              <a:off x="6043365" y="1423143"/>
              <a:ext cx="88809" cy="85384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solidFill>
                  <a:prstClr val="white"/>
                </a:solidFill>
              </a:endParaRPr>
            </a:p>
          </p:txBody>
        </p:sp>
        <p:cxnSp>
          <p:nvCxnSpPr>
            <p:cNvPr id="30" name="直線コネクタ 29"/>
            <p:cNvCxnSpPr/>
            <p:nvPr/>
          </p:nvCxnSpPr>
          <p:spPr>
            <a:xfrm>
              <a:off x="5909717" y="1622973"/>
              <a:ext cx="35992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線コネクタ 30"/>
            <p:cNvCxnSpPr/>
            <p:nvPr/>
          </p:nvCxnSpPr>
          <p:spPr>
            <a:xfrm>
              <a:off x="5903093" y="1779321"/>
              <a:ext cx="35992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二等辺三角形 31"/>
            <p:cNvSpPr/>
            <p:nvPr/>
          </p:nvSpPr>
          <p:spPr>
            <a:xfrm>
              <a:off x="6038045" y="1727592"/>
              <a:ext cx="90018" cy="94098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solidFill>
                  <a:prstClr val="white"/>
                </a:solidFill>
              </a:endParaRPr>
            </a:p>
          </p:txBody>
        </p:sp>
        <p:cxnSp>
          <p:nvCxnSpPr>
            <p:cNvPr id="33" name="直線コネクタ 32"/>
            <p:cNvCxnSpPr/>
            <p:nvPr/>
          </p:nvCxnSpPr>
          <p:spPr>
            <a:xfrm>
              <a:off x="5908007" y="1939757"/>
              <a:ext cx="35992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二等辺三角形 33"/>
            <p:cNvSpPr/>
            <p:nvPr/>
          </p:nvSpPr>
          <p:spPr>
            <a:xfrm>
              <a:off x="6036335" y="1887180"/>
              <a:ext cx="90018" cy="94098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solidFill>
                  <a:prstClr val="white"/>
                </a:solidFill>
              </a:endParaRPr>
            </a:p>
          </p:txBody>
        </p:sp>
        <p:sp>
          <p:nvSpPr>
            <p:cNvPr id="38" name="円/楕円 37"/>
            <p:cNvSpPr/>
            <p:nvPr/>
          </p:nvSpPr>
          <p:spPr>
            <a:xfrm>
              <a:off x="6038204" y="1581378"/>
              <a:ext cx="96998" cy="98381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solidFill>
                  <a:prstClr val="white"/>
                </a:solidFill>
              </a:endParaRPr>
            </a:p>
          </p:txBody>
        </p:sp>
      </p:grp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C27C1229-F55D-44C2-9576-3C3D1EEEE828}"/>
              </a:ext>
            </a:extLst>
          </p:cNvPr>
          <p:cNvSpPr/>
          <p:nvPr/>
        </p:nvSpPr>
        <p:spPr>
          <a:xfrm>
            <a:off x="811794" y="7870888"/>
            <a:ext cx="538158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S1.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he growth of each strain in modified GCM (liquid) was monitored</a:t>
            </a:r>
            <a:r>
              <a:rPr lang="en-US" altLang="ja-JP" sz="1200" kern="100" dirty="0">
                <a:solidFill>
                  <a:srgbClr val="222222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</a:t>
            </a:r>
            <a:r>
              <a:rPr lang="en-US" altLang="ja-JP" sz="12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seudomonas 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p.</a:t>
            </a:r>
            <a:r>
              <a:rPr lang="en-US" altLang="ja-JP" sz="12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s17 and the mutants were grown in Erlenmeyer flasks at 180 rpm, 28°C, after the inoculation (scaling up from an overnight culture to a fresh culture, 100 times).</a:t>
            </a:r>
            <a:r>
              <a:rPr lang="en-US" altLang="ja-JP" sz="1200" kern="100" dirty="0">
                <a:solidFill>
                  <a:srgbClr val="222222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Measurements were performed in triplicate. Symbols indicate averages, and error bars indicate 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tandard deviations</a:t>
            </a:r>
            <a:r>
              <a:rPr lang="en-US" altLang="ja-JP" sz="1200" kern="100" dirty="0">
                <a:solidFill>
                  <a:srgbClr val="222222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OD</a:t>
            </a:r>
            <a:r>
              <a:rPr lang="en-US" altLang="ja-JP" sz="1200" kern="100" baseline="-25000" dirty="0">
                <a:solidFill>
                  <a:srgbClr val="222222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600nm</a:t>
            </a:r>
            <a:r>
              <a:rPr lang="en-US" altLang="ja-JP" sz="1200" kern="100" dirty="0">
                <a:solidFill>
                  <a:srgbClr val="222222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optical density at 600 nm. </a:t>
            </a:r>
            <a:endParaRPr lang="ja-JP" altLang="ja-JP" sz="12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23573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図 18">
            <a:extLst>
              <a:ext uri="{FF2B5EF4-FFF2-40B4-BE49-F238E27FC236}">
                <a16:creationId xmlns:a16="http://schemas.microsoft.com/office/drawing/2014/main" id="{E6C0079E-CFA0-46D0-82DB-DD9609EE017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3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2519" y="4121363"/>
            <a:ext cx="1656000" cy="1581897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>
            <a:off x="1476096" y="995905"/>
            <a:ext cx="3493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/>
              <a:t>A</a:t>
            </a:r>
            <a:endParaRPr kumimoji="1" lang="ja-JP" altLang="en-US" sz="2000" b="1" dirty="0"/>
          </a:p>
        </p:txBody>
      </p:sp>
      <p:sp>
        <p:nvSpPr>
          <p:cNvPr id="4" name="テキスト ボックス 3"/>
          <p:cNvSpPr txBox="1"/>
          <p:nvPr/>
        </p:nvSpPr>
        <p:spPr>
          <a:xfrm>
            <a:off x="1476096" y="3501545"/>
            <a:ext cx="3493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/>
              <a:t>B</a:t>
            </a:r>
            <a:endParaRPr kumimoji="1" lang="ja-JP" altLang="en-US" sz="2000" b="1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476096" y="5808838"/>
            <a:ext cx="3493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/>
              <a:t>C</a:t>
            </a:r>
            <a:endParaRPr kumimoji="1" lang="ja-JP" altLang="en-US" sz="2000" b="1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2721556" y="1195960"/>
            <a:ext cx="1854720" cy="215444"/>
          </a:xfrm>
          <a:prstGeom prst="rect">
            <a:avLst/>
          </a:prstGeom>
          <a:noFill/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de-DE" altLang="ja-JP" sz="1400" b="1" i="1" dirty="0">
                <a:cs typeface="Arial" pitchFamily="34" charset="0"/>
              </a:rPr>
              <a:t>Pseudomonas syringae</a:t>
            </a:r>
            <a:endParaRPr lang="de-DE" altLang="ja-JP" sz="1400" b="1" dirty="0">
              <a:cs typeface="Arial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2362140" y="3699740"/>
            <a:ext cx="2707006" cy="215444"/>
          </a:xfrm>
          <a:prstGeom prst="rect">
            <a:avLst/>
          </a:prstGeom>
          <a:noFill/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de-DE" altLang="ja-JP" sz="1400" b="1" i="1" dirty="0">
                <a:cs typeface="Arial" pitchFamily="34" charset="0"/>
              </a:rPr>
              <a:t>Pseudomonas chlororaphis </a:t>
            </a:r>
            <a:r>
              <a:rPr lang="de-DE" altLang="ja-JP" sz="1400" b="1" dirty="0">
                <a:cs typeface="Arial" pitchFamily="34" charset="0"/>
              </a:rPr>
              <a:t>St508</a:t>
            </a: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2522567" y="6096058"/>
            <a:ext cx="2476174" cy="215444"/>
          </a:xfrm>
          <a:prstGeom prst="rect">
            <a:avLst/>
          </a:prstGeom>
          <a:noFill/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de-DE" altLang="ja-JP" sz="1400" b="1" i="1" dirty="0">
                <a:cs typeface="Arial" pitchFamily="34" charset="0"/>
              </a:rPr>
              <a:t>Pseudomonas protegens </a:t>
            </a:r>
            <a:r>
              <a:rPr lang="de-DE" altLang="ja-JP" sz="1400" b="1" dirty="0">
                <a:cs typeface="Arial" pitchFamily="34" charset="0"/>
              </a:rPr>
              <a:t>Cab57</a:t>
            </a: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4038820" y="4152702"/>
            <a:ext cx="520510" cy="169277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de-DE" altLang="ja-JP" sz="1100" b="1" dirty="0">
                <a:latin typeface="Symbol" panose="05050102010706020507" pitchFamily="18" charset="2"/>
                <a:cs typeface="Arial" pitchFamily="34" charset="0"/>
              </a:rPr>
              <a:t>D</a:t>
            </a:r>
            <a:r>
              <a:rPr lang="de-DE" altLang="ja-JP" sz="1100" b="1" i="1" dirty="0">
                <a:cs typeface="Arial" pitchFamily="34" charset="0"/>
              </a:rPr>
              <a:t>1348</a:t>
            </a: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005695" y="4158465"/>
            <a:ext cx="344180" cy="169277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de-DE" altLang="ja-JP" sz="1100" b="1" dirty="0">
                <a:cs typeface="Arial" pitchFamily="34" charset="0"/>
              </a:rPr>
              <a:t>WT</a:t>
            </a: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4047766" y="5495204"/>
            <a:ext cx="520510" cy="169277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de-DE" altLang="ja-JP" sz="1100" b="1" dirty="0">
                <a:latin typeface="Symbol" panose="05050102010706020507" pitchFamily="18" charset="2"/>
                <a:cs typeface="Arial" pitchFamily="34" charset="0"/>
              </a:rPr>
              <a:t>D</a:t>
            </a:r>
            <a:r>
              <a:rPr lang="de-DE" altLang="ja-JP" sz="1100" b="1" i="1" dirty="0">
                <a:cs typeface="Arial" pitchFamily="34" charset="0"/>
              </a:rPr>
              <a:t>1348</a:t>
            </a: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3004593" y="5500967"/>
            <a:ext cx="344180" cy="169277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de-DE" altLang="ja-JP" sz="1100" b="1" dirty="0">
                <a:cs typeface="Arial" pitchFamily="34" charset="0"/>
              </a:rPr>
              <a:t>WT</a:t>
            </a:r>
          </a:p>
        </p:txBody>
      </p:sp>
      <p:pic>
        <p:nvPicPr>
          <p:cNvPr id="22" name="図 21">
            <a:extLst>
              <a:ext uri="{FF2B5EF4-FFF2-40B4-BE49-F238E27FC236}">
                <a16:creationId xmlns:a16="http://schemas.microsoft.com/office/drawing/2014/main" id="{1E1A870B-201B-47E5-9A88-E91068923206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3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0276" y="6550368"/>
            <a:ext cx="1656000" cy="1588025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A7E0A722-95D1-4CCF-B1F4-3513FF75854C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3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7487" y="1738938"/>
            <a:ext cx="1656000" cy="1571078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194755B7-BB85-4DEE-84BA-3C298AA436D1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3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1291" y="1738938"/>
            <a:ext cx="1670259" cy="1571078"/>
          </a:xfrm>
          <a:prstGeom prst="rect">
            <a:avLst/>
          </a:prstGeom>
        </p:spPr>
      </p:pic>
      <p:sp>
        <p:nvSpPr>
          <p:cNvPr id="25" name="テキスト ボックス 24"/>
          <p:cNvSpPr txBox="1"/>
          <p:nvPr/>
        </p:nvSpPr>
        <p:spPr>
          <a:xfrm>
            <a:off x="3110569" y="1776842"/>
            <a:ext cx="520510" cy="169277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de-DE" altLang="ja-JP" sz="1100" b="1" dirty="0">
                <a:latin typeface="Symbol" panose="05050102010706020507" pitchFamily="18" charset="2"/>
                <a:cs typeface="Arial" pitchFamily="34" charset="0"/>
              </a:rPr>
              <a:t>D</a:t>
            </a:r>
            <a:r>
              <a:rPr lang="de-DE" altLang="ja-JP" sz="1100" b="1" i="1" dirty="0">
                <a:cs typeface="Arial" pitchFamily="34" charset="0"/>
              </a:rPr>
              <a:t>1348</a:t>
            </a: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2054866" y="1782605"/>
            <a:ext cx="344180" cy="169277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de-DE" altLang="ja-JP" sz="1100" b="1" dirty="0">
                <a:cs typeface="Arial" pitchFamily="34" charset="0"/>
              </a:rPr>
              <a:t>WT</a:t>
            </a: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951321" y="1770393"/>
            <a:ext cx="344180" cy="169277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de-DE" altLang="ja-JP" sz="1100" b="1" dirty="0">
                <a:cs typeface="Arial" pitchFamily="34" charset="0"/>
              </a:rPr>
              <a:t>WT</a:t>
            </a: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020375" y="1775183"/>
            <a:ext cx="520510" cy="169277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de-DE" altLang="ja-JP" sz="1100" b="1" dirty="0">
                <a:latin typeface="Symbol" panose="05050102010706020507" pitchFamily="18" charset="2"/>
                <a:cs typeface="Arial" pitchFamily="34" charset="0"/>
              </a:rPr>
              <a:t>D</a:t>
            </a:r>
            <a:r>
              <a:rPr lang="de-DE" altLang="ja-JP" sz="1100" b="1" i="1" dirty="0">
                <a:cs typeface="Arial" pitchFamily="34" charset="0"/>
              </a:rPr>
              <a:t>1348</a:t>
            </a: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3113884" y="3111005"/>
            <a:ext cx="520510" cy="169277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de-DE" altLang="ja-JP" sz="1100" b="1" dirty="0">
                <a:latin typeface="Symbol" panose="05050102010706020507" pitchFamily="18" charset="2"/>
                <a:cs typeface="Arial" pitchFamily="34" charset="0"/>
              </a:rPr>
              <a:t>D</a:t>
            </a:r>
            <a:r>
              <a:rPr lang="de-DE" altLang="ja-JP" sz="1100" b="1" i="1" dirty="0">
                <a:cs typeface="Arial" pitchFamily="34" charset="0"/>
              </a:rPr>
              <a:t>1348</a:t>
            </a: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2058181" y="3116768"/>
            <a:ext cx="344180" cy="169277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de-DE" altLang="ja-JP" sz="1100" b="1" dirty="0">
                <a:cs typeface="Arial" pitchFamily="34" charset="0"/>
              </a:rPr>
              <a:t>WT</a:t>
            </a: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5022172" y="3111005"/>
            <a:ext cx="520510" cy="169277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de-DE" altLang="ja-JP" sz="1100" b="1" dirty="0">
                <a:latin typeface="Symbol" panose="05050102010706020507" pitchFamily="18" charset="2"/>
                <a:cs typeface="Arial" pitchFamily="34" charset="0"/>
              </a:rPr>
              <a:t>D</a:t>
            </a:r>
            <a:r>
              <a:rPr lang="de-DE" altLang="ja-JP" sz="1100" b="1" i="1" dirty="0">
                <a:cs typeface="Arial" pitchFamily="34" charset="0"/>
              </a:rPr>
              <a:t>1348</a:t>
            </a: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966469" y="3116768"/>
            <a:ext cx="344180" cy="169277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de-DE" altLang="ja-JP" sz="1100" b="1" dirty="0">
                <a:cs typeface="Arial" pitchFamily="34" charset="0"/>
              </a:rPr>
              <a:t>WT</a:t>
            </a: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2251345" y="1450914"/>
            <a:ext cx="1247504" cy="215444"/>
          </a:xfrm>
          <a:prstGeom prst="rect">
            <a:avLst/>
          </a:prstGeom>
          <a:noFill/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de-DE" altLang="ja-JP" sz="1400" b="1" dirty="0">
                <a:cs typeface="Arial" pitchFamily="34" charset="0"/>
              </a:rPr>
              <a:t>pv. pisi 730032</a:t>
            </a: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4033575" y="1444290"/>
            <a:ext cx="1442941" cy="215444"/>
          </a:xfrm>
          <a:prstGeom prst="rect">
            <a:avLst/>
          </a:prstGeom>
          <a:noFill/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de-DE" altLang="ja-JP" sz="1400" b="1" dirty="0">
                <a:cs typeface="Arial" pitchFamily="34" charset="0"/>
              </a:rPr>
              <a:t>pv. tabaci 301612</a:t>
            </a: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972389" y="6582419"/>
            <a:ext cx="344180" cy="169277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de-DE" altLang="ja-JP" sz="1100" b="1" dirty="0">
                <a:cs typeface="Arial" pitchFamily="34" charset="0"/>
              </a:rPr>
              <a:t>WT</a:t>
            </a: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4025360" y="6567331"/>
            <a:ext cx="520510" cy="169277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de-DE" altLang="ja-JP" sz="1100" b="1" dirty="0">
                <a:latin typeface="Symbol" panose="05050102010706020507" pitchFamily="18" charset="2"/>
                <a:cs typeface="Arial" pitchFamily="34" charset="0"/>
              </a:rPr>
              <a:t>D</a:t>
            </a:r>
            <a:r>
              <a:rPr lang="de-DE" altLang="ja-JP" sz="1100" b="1" i="1" dirty="0">
                <a:cs typeface="Arial" pitchFamily="34" charset="0"/>
              </a:rPr>
              <a:t>1348</a:t>
            </a: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2978032" y="7942742"/>
            <a:ext cx="344180" cy="169277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de-DE" altLang="ja-JP" sz="1100" b="1" dirty="0">
                <a:cs typeface="Arial" pitchFamily="34" charset="0"/>
              </a:rPr>
              <a:t>WT</a:t>
            </a: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4031003" y="7938943"/>
            <a:ext cx="520510" cy="169277"/>
          </a:xfrm>
          <a:prstGeom prst="rect">
            <a:avLst/>
          </a:prstGeom>
          <a:solidFill>
            <a:schemeClr val="bg1"/>
          </a:solidFill>
        </p:spPr>
        <p:txBody>
          <a:bodyPr wrap="none" lIns="72000" tIns="0" rIns="72000" bIns="0" rtlCol="0">
            <a:spAutoFit/>
          </a:bodyPr>
          <a:lstStyle/>
          <a:p>
            <a:pPr algn="ctr"/>
            <a:r>
              <a:rPr lang="de-DE" altLang="ja-JP" sz="1100" b="1" dirty="0">
                <a:latin typeface="Symbol" panose="05050102010706020507" pitchFamily="18" charset="2"/>
                <a:cs typeface="Arial" pitchFamily="34" charset="0"/>
              </a:rPr>
              <a:t>D</a:t>
            </a:r>
            <a:r>
              <a:rPr lang="de-DE" altLang="ja-JP" sz="1100" b="1" i="1" dirty="0">
                <a:cs typeface="Arial" pitchFamily="34" charset="0"/>
              </a:rPr>
              <a:t>1348</a:t>
            </a: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7BF39825-8018-4C96-9A41-A33BCA97E7EE}"/>
              </a:ext>
            </a:extLst>
          </p:cNvPr>
          <p:cNvSpPr/>
          <p:nvPr/>
        </p:nvSpPr>
        <p:spPr>
          <a:xfrm>
            <a:off x="1010794" y="8509731"/>
            <a:ext cx="497611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S2.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ntibiotic activities of </a:t>
            </a:r>
            <a:r>
              <a:rPr lang="en-US" altLang="ja-JP" sz="12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seudomonas 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p. Os17 wild type (WT) and the </a:t>
            </a:r>
            <a:r>
              <a:rPr lang="en-US" altLang="ja-JP" sz="12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348 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utant (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  <a:sym typeface="Symbol" panose="05050102010706020507" pitchFamily="18" charset="2"/>
              </a:rPr>
              <a:t></a:t>
            </a:r>
            <a:r>
              <a:rPr lang="en-US" altLang="ja-JP" sz="12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348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grown on modified GCM plates. The indicator strains are </a:t>
            </a:r>
            <a:r>
              <a:rPr lang="en-US" altLang="ja-JP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A) </a:t>
            </a:r>
            <a:r>
              <a:rPr lang="en-US" altLang="ja-JP" sz="12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. </a:t>
            </a:r>
            <a:r>
              <a:rPr lang="en-US" altLang="ja-JP" sz="1200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yringae</a:t>
            </a:r>
            <a:r>
              <a:rPr lang="en-US" altLang="ja-JP" sz="12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vs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isi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730032 (left) and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abaci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301612 (right), </a:t>
            </a:r>
            <a:r>
              <a:rPr lang="en-US" altLang="ja-JP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B) </a:t>
            </a:r>
            <a:r>
              <a:rPr lang="en-US" altLang="ja-JP" sz="12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. </a:t>
            </a:r>
            <a:r>
              <a:rPr lang="en-US" altLang="ja-JP" sz="1200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hlororaphis</a:t>
            </a:r>
            <a:r>
              <a:rPr lang="en-US" altLang="ja-JP" sz="12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t508, and </a:t>
            </a:r>
            <a:r>
              <a:rPr lang="en-US" altLang="ja-JP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C) </a:t>
            </a:r>
            <a:r>
              <a:rPr lang="en-US" altLang="ja-JP" sz="12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. </a:t>
            </a:r>
            <a:r>
              <a:rPr lang="en-US" altLang="ja-JP" sz="1200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rotegens</a:t>
            </a:r>
            <a:r>
              <a:rPr lang="en-US" altLang="ja-JP" sz="12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ab57. </a:t>
            </a:r>
            <a:endParaRPr lang="ja-JP" altLang="ja-JP" sz="12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14545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正方形/長方形 2"/>
          <p:cNvSpPr/>
          <p:nvPr/>
        </p:nvSpPr>
        <p:spPr>
          <a:xfrm>
            <a:off x="1807207" y="4086944"/>
            <a:ext cx="4647426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22 </a:t>
            </a:r>
            <a:r>
              <a:rPr lang="ja-JP" alt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DFAAQLHQDPEAAAKGIGVHLSATEVGAVKSIDTAKLTSAG </a:t>
            </a:r>
            <a:r>
              <a:rPr lang="en-US" altLang="ja-JP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62</a:t>
            </a:r>
          </a:p>
          <a:p>
            <a:r>
              <a:rPr lang="en-US" altLang="ja-JP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D   + H+DP      + ++  A+EV  ++     KL++AG</a:t>
            </a:r>
          </a:p>
          <a:p>
            <a:r>
              <a:rPr lang="en-US" altLang="ja-JP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43 DLETRPHEDPLRFRSQLSLNFPASEVSDLQFEREGKLSAAG 83</a:t>
            </a:r>
            <a:endParaRPr lang="ja-JP" altLang="en-US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4" name="正方形/長方形 3"/>
          <p:cNvSpPr/>
          <p:nvPr/>
        </p:nvSpPr>
        <p:spPr>
          <a:xfrm>
            <a:off x="320903" y="4456276"/>
            <a:ext cx="148630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WP_002551422.1</a:t>
            </a:r>
          </a:p>
          <a:p>
            <a:r>
              <a:rPr lang="en-US" altLang="ja-JP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(</a:t>
            </a:r>
            <a:r>
              <a:rPr lang="en-US" altLang="ja-JP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ImpH</a:t>
            </a:r>
            <a:r>
              <a:rPr lang="en-US" altLang="ja-JP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)</a:t>
            </a:r>
            <a:endParaRPr lang="ja-JP" altLang="en-US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" name="正方形/長方形 4"/>
          <p:cNvSpPr/>
          <p:nvPr/>
        </p:nvSpPr>
        <p:spPr>
          <a:xfrm>
            <a:off x="317971" y="4086944"/>
            <a:ext cx="74251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Os1348</a:t>
            </a:r>
            <a:endParaRPr lang="ja-JP" altLang="en-US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179F1E49-2AD4-4FB4-9CAD-584542BE4BA7}"/>
              </a:ext>
            </a:extLst>
          </p:cNvPr>
          <p:cNvSpPr/>
          <p:nvPr/>
        </p:nvSpPr>
        <p:spPr>
          <a:xfrm>
            <a:off x="865414" y="5913095"/>
            <a:ext cx="512717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S3.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equence alignment of the Os1348 protein (amino acids 22-62) with the type VI secretion protein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mpH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of the </a:t>
            </a:r>
            <a:r>
              <a:rPr lang="en-US" altLang="ja-JP" sz="12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seudomonas </a:t>
            </a:r>
            <a:r>
              <a:rPr lang="en-US" altLang="ja-JP" sz="1200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yringae</a:t>
            </a:r>
            <a:r>
              <a:rPr lang="en-US" altLang="ja-JP" sz="1200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roup (amino acids 43-83) using the NCBI Blast Microbes database.</a:t>
            </a:r>
            <a:endParaRPr lang="ja-JP" altLang="ja-JP" sz="12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43189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515</TotalTime>
  <Words>287</Words>
  <Application>Microsoft Office PowerPoint</Application>
  <PresentationFormat>A4 210 x 297 mm</PresentationFormat>
  <Paragraphs>46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1" baseType="lpstr">
      <vt:lpstr>Arial</vt:lpstr>
      <vt:lpstr>Calibri</vt:lpstr>
      <vt:lpstr>Calibri Light</vt:lpstr>
      <vt:lpstr>Century</vt:lpstr>
      <vt:lpstr>Courier New</vt:lpstr>
      <vt:lpstr>Symbo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竹内香純</dc:creator>
  <cp:lastModifiedBy>竹内　香純</cp:lastModifiedBy>
  <cp:revision>99</cp:revision>
  <cp:lastPrinted>2019-10-24T06:51:07Z</cp:lastPrinted>
  <dcterms:created xsi:type="dcterms:W3CDTF">2016-11-10T05:12:14Z</dcterms:created>
  <dcterms:modified xsi:type="dcterms:W3CDTF">2020-11-04T06:13:04Z</dcterms:modified>
</cp:coreProperties>
</file>